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4" r:id="rId2"/>
    <p:sldId id="265" r:id="rId3"/>
    <p:sldId id="266" r:id="rId4"/>
    <p:sldId id="256" r:id="rId5"/>
    <p:sldId id="260" r:id="rId6"/>
    <p:sldId id="261" r:id="rId7"/>
    <p:sldId id="262" r:id="rId8"/>
    <p:sldId id="257" r:id="rId9"/>
    <p:sldId id="263" r:id="rId10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010" autoAdjust="0"/>
  </p:normalViewPr>
  <p:slideViewPr>
    <p:cSldViewPr>
      <p:cViewPr varScale="1">
        <p:scale>
          <a:sx n="78" d="100"/>
          <a:sy n="78" d="100"/>
        </p:scale>
        <p:origin x="1522" y="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29EC42D0-69CA-4EA4-BE85-06083BE39E77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B822C89-33F0-4756-9936-8EBA4AD0A6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067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9296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919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91047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4864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0854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88108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12403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27880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22C89-33F0-4756-9936-8EBA4AD0A606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199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853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785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95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844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456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176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052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743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938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577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255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1B4B4-6B6D-4C24-8BD8-A41A6E111FC5}" type="datetimeFigureOut">
              <a:rPr lang="en-GB" smtClean="0"/>
              <a:t>26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8298E-3AFB-48BA-9872-A05681B897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123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jpeg"/><Relationship Id="rId4" Type="http://schemas.openxmlformats.org/officeDocument/2006/relationships/image" Target="../media/image26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jpeg"/><Relationship Id="rId4" Type="http://schemas.openxmlformats.org/officeDocument/2006/relationships/image" Target="../media/image2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275" y="3798863"/>
            <a:ext cx="3201987" cy="1430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5297" y="188640"/>
            <a:ext cx="2765425" cy="1316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0491" y="5399218"/>
            <a:ext cx="2973387" cy="744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0152" y="2924944"/>
            <a:ext cx="665162" cy="544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17947" y="1564682"/>
            <a:ext cx="6305550" cy="2008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2488009" y="404664"/>
            <a:ext cx="61377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3101788" y="377479"/>
            <a:ext cx="61377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2593209" y="4637739"/>
            <a:ext cx="616156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3101788" y="944724"/>
            <a:ext cx="616156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2557350" y="5632821"/>
            <a:ext cx="589262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3146611" y="5623857"/>
            <a:ext cx="654423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2" name="Straight Connector 21"/>
          <p:cNvCxnSpPr>
            <a:stCxn id="16" idx="2"/>
          </p:cNvCxnSpPr>
          <p:nvPr/>
        </p:nvCxnSpPr>
        <p:spPr>
          <a:xfrm flipH="1">
            <a:off x="1619672" y="908720"/>
            <a:ext cx="1175227" cy="12961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>
            <a:stCxn id="17" idx="2"/>
          </p:cNvCxnSpPr>
          <p:nvPr/>
        </p:nvCxnSpPr>
        <p:spPr>
          <a:xfrm>
            <a:off x="3408678" y="881535"/>
            <a:ext cx="1451354" cy="132332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473822" y="1196752"/>
            <a:ext cx="1098178" cy="16561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>
            <a:endCxn id="18" idx="0"/>
          </p:cNvCxnSpPr>
          <p:nvPr/>
        </p:nvCxnSpPr>
        <p:spPr>
          <a:xfrm>
            <a:off x="1907704" y="3140968"/>
            <a:ext cx="993583" cy="149677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1763688" y="3356992"/>
            <a:ext cx="1088293" cy="22668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>
            <a:off x="3473822" y="3356992"/>
            <a:ext cx="1098178" cy="22322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 rot="16200000">
            <a:off x="1202245" y="36305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1820119" y="53310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2416969" y="1740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011934" y="18700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1403842" y="37466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2027119" y="37747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2597974" y="1884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3213752" y="1884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3446515" y="1850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1655413" y="41452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2264189" y="41960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2810201" y="19457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1227165" y="188640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1823889" y="-6479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41" name="Straight Connector 40"/>
          <p:cNvCxnSpPr/>
          <p:nvPr/>
        </p:nvCxnSpPr>
        <p:spPr>
          <a:xfrm>
            <a:off x="3101833" y="188640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162813" y="-1813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1337086" y="403264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1964135" y="403264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2498389" y="40157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146775" y="402876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1538683" y="404706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2123922" y="404706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2699986" y="403020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348593" y="403020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3581356" y="402684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1760133" y="404370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2336197" y="404370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2912261" y="403633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55" name="Straight Connector 54"/>
          <p:cNvCxnSpPr/>
          <p:nvPr/>
        </p:nvCxnSpPr>
        <p:spPr>
          <a:xfrm>
            <a:off x="1362006" y="3933056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949270" y="3642333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57" name="Straight Connector 56"/>
          <p:cNvCxnSpPr/>
          <p:nvPr/>
        </p:nvCxnSpPr>
        <p:spPr>
          <a:xfrm>
            <a:off x="3236674" y="393305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245337" y="368683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3860173" y="302690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240944" y="17485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cxnSp>
        <p:nvCxnSpPr>
          <p:cNvPr id="60" name="Straight Arrow Connector 59"/>
          <p:cNvCxnSpPr/>
          <p:nvPr/>
        </p:nvCxnSpPr>
        <p:spPr>
          <a:xfrm flipH="1">
            <a:off x="3964867" y="4167204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345638" y="4039373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1256771" y="529562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1903677" y="531248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2468191" y="529562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3042081" y="530861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1480134" y="5309446"/>
            <a:ext cx="4067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2100869" y="531005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2669788" y="53100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3243899" y="53100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3476662" y="530669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1729936" y="532355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2285522" y="532691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2870451" y="531618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4" name="Straight Connector 73"/>
          <p:cNvCxnSpPr/>
          <p:nvPr/>
        </p:nvCxnSpPr>
        <p:spPr>
          <a:xfrm>
            <a:off x="1276353" y="6042194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1873077" y="5847075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76" name="Straight Connector 75"/>
          <p:cNvCxnSpPr/>
          <p:nvPr/>
        </p:nvCxnSpPr>
        <p:spPr>
          <a:xfrm>
            <a:off x="3151021" y="6042194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3212001" y="583541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78" name="Straight Arrow Connector 77"/>
          <p:cNvCxnSpPr/>
          <p:nvPr/>
        </p:nvCxnSpPr>
        <p:spPr>
          <a:xfrm flipH="1">
            <a:off x="3860173" y="5447052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4240944" y="5319221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B1AE7B-CBE5-4F06-A605-9B072017FE98}"/>
              </a:ext>
            </a:extLst>
          </p:cNvPr>
          <p:cNvSpPr txBox="1"/>
          <p:nvPr/>
        </p:nvSpPr>
        <p:spPr>
          <a:xfrm>
            <a:off x="4044700" y="722645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C0DFCA0-A8B1-422F-A230-540278DD2B4D}"/>
              </a:ext>
            </a:extLst>
          </p:cNvPr>
          <p:cNvSpPr txBox="1"/>
          <p:nvPr/>
        </p:nvSpPr>
        <p:spPr>
          <a:xfrm>
            <a:off x="4433677" y="4492568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6A9BE58-2225-46B3-827D-C44D0804E283}"/>
              </a:ext>
            </a:extLst>
          </p:cNvPr>
          <p:cNvSpPr txBox="1"/>
          <p:nvPr/>
        </p:nvSpPr>
        <p:spPr>
          <a:xfrm>
            <a:off x="4218582" y="5666442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</p:spTree>
    <p:extLst>
      <p:ext uri="{BB962C8B-B14F-4D97-AF65-F5344CB8AC3E}">
        <p14:creationId xmlns:p14="http://schemas.microsoft.com/office/powerpoint/2010/main" val="453413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17947" y="1564682"/>
            <a:ext cx="6305550" cy="2008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6231" y="5294428"/>
            <a:ext cx="2951162" cy="608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144463"/>
            <a:ext cx="3008312" cy="1495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6231" y="3752473"/>
            <a:ext cx="2862262" cy="1528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Rectangle 22"/>
          <p:cNvSpPr/>
          <p:nvPr/>
        </p:nvSpPr>
        <p:spPr>
          <a:xfrm>
            <a:off x="3626526" y="448235"/>
            <a:ext cx="613779" cy="44393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/>
          <p:cNvSpPr/>
          <p:nvPr/>
        </p:nvSpPr>
        <p:spPr>
          <a:xfrm>
            <a:off x="4778188" y="511949"/>
            <a:ext cx="613779" cy="38022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4778188" y="1016732"/>
            <a:ext cx="616156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/>
          <p:cNvSpPr/>
          <p:nvPr/>
        </p:nvSpPr>
        <p:spPr>
          <a:xfrm>
            <a:off x="3415553" y="4611288"/>
            <a:ext cx="616156" cy="252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3425012" y="5472420"/>
            <a:ext cx="600141" cy="21120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4572000" y="5445525"/>
            <a:ext cx="690282" cy="25602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2" name="Straight Connector 31"/>
          <p:cNvCxnSpPr/>
          <p:nvPr/>
        </p:nvCxnSpPr>
        <p:spPr>
          <a:xfrm>
            <a:off x="5086266" y="1268760"/>
            <a:ext cx="411127" cy="158417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5394344" y="702062"/>
            <a:ext cx="545808" cy="15748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H="1">
            <a:off x="2843808" y="892175"/>
            <a:ext cx="1089607" cy="132107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987824" y="3068960"/>
            <a:ext cx="737258" cy="154232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H="1">
            <a:off x="4917142" y="3284984"/>
            <a:ext cx="474825" cy="21874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2411760" y="3284984"/>
            <a:ext cx="1080120" cy="21874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2900239" y="24360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548311" y="24360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4124375" y="22674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4700439" y="23972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3132034" y="25803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3708098" y="25803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4325972" y="24117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4902036" y="24117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5144509" y="23781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3374507" y="25467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3920373" y="25467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4526635" y="24730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2942136" y="241366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538860" y="46247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4816804" y="24136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4877784" y="3458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45" name="Straight Arrow Connector 44"/>
          <p:cNvCxnSpPr/>
          <p:nvPr/>
        </p:nvCxnSpPr>
        <p:spPr>
          <a:xfrm flipH="1">
            <a:off x="5544997" y="378170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925768" y="25033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2756223" y="410310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362485" y="410310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908183" y="408623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4556569" y="409922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2948477" y="411752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3533716" y="411752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4109780" y="410066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4758387" y="410066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4991150" y="409730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3169927" y="411416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3759949" y="411416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4310611" y="410679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2771800" y="4100859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3368524" y="3905740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4646468" y="4100859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707448" y="389408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64" name="Straight Arrow Connector 63"/>
          <p:cNvCxnSpPr/>
          <p:nvPr/>
        </p:nvCxnSpPr>
        <p:spPr>
          <a:xfrm flipH="1">
            <a:off x="5374661" y="4237663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5755432" y="4109832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2714413" y="56948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3362485" y="56948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3908183" y="567795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4556569" y="569094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2948477" y="57092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3533716" y="57092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4109780" y="569238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4758387" y="569238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4991150" y="568902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3169927" y="57058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3759949" y="57058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4310611" y="569851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8" name="Straight Connector 77"/>
          <p:cNvCxnSpPr/>
          <p:nvPr/>
        </p:nvCxnSpPr>
        <p:spPr>
          <a:xfrm>
            <a:off x="2771800" y="6021288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3347864" y="6063099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80" name="Straight Connector 79"/>
          <p:cNvCxnSpPr/>
          <p:nvPr/>
        </p:nvCxnSpPr>
        <p:spPr>
          <a:xfrm>
            <a:off x="4646468" y="6021288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4686788" y="605144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82" name="Straight Arrow Connector 81"/>
          <p:cNvCxnSpPr/>
          <p:nvPr/>
        </p:nvCxnSpPr>
        <p:spPr>
          <a:xfrm flipH="1">
            <a:off x="5374661" y="5829383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5755432" y="5701552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30927DF-C2FE-48F2-975E-F9827AE3907C}"/>
              </a:ext>
            </a:extLst>
          </p:cNvPr>
          <p:cNvSpPr txBox="1"/>
          <p:nvPr/>
        </p:nvSpPr>
        <p:spPr>
          <a:xfrm>
            <a:off x="5735346" y="776894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102868A-D3FC-48CF-9AC9-170AFD85BBD8}"/>
              </a:ext>
            </a:extLst>
          </p:cNvPr>
          <p:cNvSpPr txBox="1"/>
          <p:nvPr/>
        </p:nvSpPr>
        <p:spPr>
          <a:xfrm>
            <a:off x="5464804" y="4567136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3FC0BE9-119B-41BA-8F0F-9E9DE7C389C8}"/>
              </a:ext>
            </a:extLst>
          </p:cNvPr>
          <p:cNvSpPr txBox="1"/>
          <p:nvPr/>
        </p:nvSpPr>
        <p:spPr>
          <a:xfrm>
            <a:off x="923977" y="5443603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</p:spTree>
    <p:extLst>
      <p:ext uri="{BB962C8B-B14F-4D97-AF65-F5344CB8AC3E}">
        <p14:creationId xmlns:p14="http://schemas.microsoft.com/office/powerpoint/2010/main" val="23187857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55548" y="1772816"/>
            <a:ext cx="6305550" cy="2008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3698" y="5372321"/>
            <a:ext cx="2889250" cy="708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799" y="135690"/>
            <a:ext cx="3113087" cy="1454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3783854"/>
            <a:ext cx="3268662" cy="142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3137647" y="394448"/>
            <a:ext cx="636494" cy="4213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Straight Connector 6"/>
          <p:cNvCxnSpPr>
            <a:endCxn id="10" idx="0"/>
          </p:cNvCxnSpPr>
          <p:nvPr/>
        </p:nvCxnSpPr>
        <p:spPr>
          <a:xfrm flipH="1">
            <a:off x="2967317" y="3284984"/>
            <a:ext cx="349623" cy="12063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4932040" y="394448"/>
            <a:ext cx="636494" cy="4213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/>
          <p:cNvSpPr/>
          <p:nvPr/>
        </p:nvSpPr>
        <p:spPr>
          <a:xfrm>
            <a:off x="2617693" y="4491318"/>
            <a:ext cx="699247" cy="4213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3" name="Straight Connector 12"/>
          <p:cNvCxnSpPr/>
          <p:nvPr/>
        </p:nvCxnSpPr>
        <p:spPr>
          <a:xfrm>
            <a:off x="3469340" y="815788"/>
            <a:ext cx="0" cy="16051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4949970" y="959224"/>
            <a:ext cx="636494" cy="3406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2617693" y="5578021"/>
            <a:ext cx="699248" cy="22214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4491812" y="5571031"/>
            <a:ext cx="680823" cy="2560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9" name="Straight Connector 18"/>
          <p:cNvCxnSpPr/>
          <p:nvPr/>
        </p:nvCxnSpPr>
        <p:spPr>
          <a:xfrm flipH="1">
            <a:off x="3119717" y="3573016"/>
            <a:ext cx="588187" cy="19980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>
            <a:off x="4832224" y="3573016"/>
            <a:ext cx="1683992" cy="19980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004048" y="1268760"/>
            <a:ext cx="1224136" cy="1800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 flipV="1">
            <a:off x="5004048" y="764704"/>
            <a:ext cx="1224136" cy="16561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6200000">
            <a:off x="2582670" y="399432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218469" y="399432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794533" y="399044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424826" y="399044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2816734" y="400874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3401973" y="400874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3978037" y="400487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626644" y="400487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4859407" y="398852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038184" y="400538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3632341" y="400538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4208405" y="399801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2640057" y="3933056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236781" y="3728690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37" name="Straight Connector 36"/>
          <p:cNvCxnSpPr/>
          <p:nvPr/>
        </p:nvCxnSpPr>
        <p:spPr>
          <a:xfrm>
            <a:off x="4514725" y="393305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4575705" y="371703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5242918" y="4128885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623689" y="4001054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2597213" y="586769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3260279" y="583883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3836343" y="582197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4442605" y="583495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2804461" y="585326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3420066" y="585326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4037940" y="583640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4644202" y="583640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4886675" y="583304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3056277" y="584990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3662539" y="584990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4238603" y="58425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2627784" y="6165304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3203848" y="6207115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75" name="Straight Connector 74"/>
          <p:cNvCxnSpPr/>
          <p:nvPr/>
        </p:nvCxnSpPr>
        <p:spPr>
          <a:xfrm>
            <a:off x="4502452" y="6165304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542772" y="619545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77" name="Straight Arrow Connector 76"/>
          <p:cNvCxnSpPr/>
          <p:nvPr/>
        </p:nvCxnSpPr>
        <p:spPr>
          <a:xfrm flipH="1">
            <a:off x="5230645" y="5973399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5611416" y="5845568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3043540" y="1296337"/>
            <a:ext cx="360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3679339" y="129633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1" name="TextBox 80"/>
          <p:cNvSpPr txBox="1"/>
          <p:nvPr/>
        </p:nvSpPr>
        <p:spPr>
          <a:xfrm rot="16200000">
            <a:off x="4255403" y="129633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2" name="TextBox 81"/>
          <p:cNvSpPr txBox="1"/>
          <p:nvPr/>
        </p:nvSpPr>
        <p:spPr>
          <a:xfrm rot="16200000">
            <a:off x="4885696" y="129633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3" name="TextBox 82"/>
          <p:cNvSpPr txBox="1"/>
          <p:nvPr/>
        </p:nvSpPr>
        <p:spPr>
          <a:xfrm rot="16200000">
            <a:off x="3277604" y="131076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4" name="TextBox 83"/>
          <p:cNvSpPr txBox="1"/>
          <p:nvPr/>
        </p:nvSpPr>
        <p:spPr>
          <a:xfrm rot="16200000">
            <a:off x="3862843" y="131076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5" name="TextBox 84"/>
          <p:cNvSpPr txBox="1"/>
          <p:nvPr/>
        </p:nvSpPr>
        <p:spPr>
          <a:xfrm rot="16200000">
            <a:off x="4438907" y="131076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6" name="TextBox 85"/>
          <p:cNvSpPr txBox="1"/>
          <p:nvPr/>
        </p:nvSpPr>
        <p:spPr>
          <a:xfrm rot="16200000">
            <a:off x="5087514" y="131076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7" name="TextBox 86"/>
          <p:cNvSpPr txBox="1"/>
          <p:nvPr/>
        </p:nvSpPr>
        <p:spPr>
          <a:xfrm rot="16200000">
            <a:off x="5320277" y="129441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88" name="TextBox 87"/>
          <p:cNvSpPr txBox="1"/>
          <p:nvPr/>
        </p:nvSpPr>
        <p:spPr>
          <a:xfrm rot="16200000">
            <a:off x="3499054" y="130740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89" name="TextBox 88"/>
          <p:cNvSpPr txBox="1"/>
          <p:nvPr/>
        </p:nvSpPr>
        <p:spPr>
          <a:xfrm rot="16200000">
            <a:off x="4093211" y="130740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90" name="TextBox 89"/>
          <p:cNvSpPr txBox="1"/>
          <p:nvPr/>
        </p:nvSpPr>
        <p:spPr>
          <a:xfrm rot="16200000">
            <a:off x="4670651" y="131412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91" name="Straight Connector 90"/>
          <p:cNvCxnSpPr/>
          <p:nvPr/>
        </p:nvCxnSpPr>
        <p:spPr>
          <a:xfrm>
            <a:off x="3100927" y="332656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3697651" y="128290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93" name="Straight Connector 92"/>
          <p:cNvCxnSpPr/>
          <p:nvPr/>
        </p:nvCxnSpPr>
        <p:spPr>
          <a:xfrm>
            <a:off x="4975595" y="33265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5036575" y="11663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95" name="Straight Arrow Connector 94"/>
          <p:cNvCxnSpPr/>
          <p:nvPr/>
        </p:nvCxnSpPr>
        <p:spPr>
          <a:xfrm flipH="1">
            <a:off x="5703788" y="453482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6084559" y="325651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BDC7864-672A-481B-B3F3-90C069B6D391}"/>
              </a:ext>
            </a:extLst>
          </p:cNvPr>
          <p:cNvSpPr txBox="1"/>
          <p:nvPr/>
        </p:nvSpPr>
        <p:spPr>
          <a:xfrm>
            <a:off x="5940943" y="931437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FA11092-11E7-4487-B8C6-5327B6E39D8A}"/>
              </a:ext>
            </a:extLst>
          </p:cNvPr>
          <p:cNvSpPr txBox="1"/>
          <p:nvPr/>
        </p:nvSpPr>
        <p:spPr>
          <a:xfrm>
            <a:off x="5405550" y="4628617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0F41970-6451-46CE-B472-97C62C7D8E5C}"/>
              </a:ext>
            </a:extLst>
          </p:cNvPr>
          <p:cNvSpPr txBox="1"/>
          <p:nvPr/>
        </p:nvSpPr>
        <p:spPr>
          <a:xfrm>
            <a:off x="5327632" y="5472782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</p:spTree>
    <p:extLst>
      <p:ext uri="{BB962C8B-B14F-4D97-AF65-F5344CB8AC3E}">
        <p14:creationId xmlns:p14="http://schemas.microsoft.com/office/powerpoint/2010/main" val="1382229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7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851273" y="100968"/>
            <a:ext cx="6305550" cy="2047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0355" y="5517232"/>
            <a:ext cx="3449637" cy="850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690885" y="2171637"/>
            <a:ext cx="3521075" cy="1712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 descr="C:\Users\Anna\Documents\PLoS ONE Response\Figure 5 full blots\9 wks\1_Cortex 9 wks HTT soluble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420168" y="3811027"/>
            <a:ext cx="3200400" cy="1635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3347864" y="2425848"/>
            <a:ext cx="664096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3347864" y="3146672"/>
            <a:ext cx="664096" cy="35433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2683768" y="5726976"/>
            <a:ext cx="664096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>
            <a:off x="2627784" y="2425848"/>
            <a:ext cx="664096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5048657" y="4736554"/>
            <a:ext cx="649793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3385964" y="5743322"/>
            <a:ext cx="720228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8" name="Straight Connector 7"/>
          <p:cNvCxnSpPr>
            <a:stCxn id="13" idx="0"/>
          </p:cNvCxnSpPr>
          <p:nvPr/>
        </p:nvCxnSpPr>
        <p:spPr>
          <a:xfrm flipH="1" flipV="1">
            <a:off x="2847568" y="1124744"/>
            <a:ext cx="112264" cy="13011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stCxn id="14" idx="0"/>
          </p:cNvCxnSpPr>
          <p:nvPr/>
        </p:nvCxnSpPr>
        <p:spPr>
          <a:xfrm flipH="1" flipV="1">
            <a:off x="3307906" y="1628800"/>
            <a:ext cx="2065648" cy="31077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stCxn id="12" idx="0"/>
          </p:cNvCxnSpPr>
          <p:nvPr/>
        </p:nvCxnSpPr>
        <p:spPr>
          <a:xfrm flipH="1" flipV="1">
            <a:off x="2683768" y="1916832"/>
            <a:ext cx="332048" cy="38101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3797124" y="1844824"/>
            <a:ext cx="2503068" cy="388215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4011960" y="1556793"/>
            <a:ext cx="1784176" cy="16258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4011960" y="980728"/>
            <a:ext cx="1640160" cy="14451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1475656" y="3645024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158635" y="3614827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cxnSp>
        <p:nvCxnSpPr>
          <p:cNvPr id="37" name="Straight Connector 36"/>
          <p:cNvCxnSpPr/>
          <p:nvPr/>
        </p:nvCxnSpPr>
        <p:spPr>
          <a:xfrm>
            <a:off x="3419872" y="3645024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347864" y="361482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3794533" y="386909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442605" y="389801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5018669" y="381811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5738749" y="380327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068138" y="385000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4614004" y="386780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5190068" y="382113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5910148" y="37888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6152621" y="376637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4280413" y="386444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4856477" y="389037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5390731" y="383440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55" name="Straight Arrow Connector 54"/>
          <p:cNvCxnSpPr/>
          <p:nvPr/>
        </p:nvCxnSpPr>
        <p:spPr>
          <a:xfrm flipH="1">
            <a:off x="6501649" y="3969769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6882420" y="3841938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5485988" y="387072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58" name="TextBox 57"/>
          <p:cNvSpPr txBox="1"/>
          <p:nvPr/>
        </p:nvSpPr>
        <p:spPr>
          <a:xfrm>
            <a:off x="4634021" y="5394121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59" name="TextBox 58"/>
          <p:cNvSpPr txBox="1"/>
          <p:nvPr/>
        </p:nvSpPr>
        <p:spPr>
          <a:xfrm>
            <a:off x="5823250" y="539412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3874071" y="5364612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5868216" y="5364612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 rot="16200000">
            <a:off x="1460188" y="556150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2066341" y="557366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2612207" y="557366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3362485" y="549568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1661676" y="55424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2237740" y="555923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2813804" y="55890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3564082" y="548126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3776357" y="551367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1862339" y="555685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2438403" y="55856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3014467" y="5562598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4" name="Straight Arrow Connector 73"/>
          <p:cNvCxnSpPr/>
          <p:nvPr/>
        </p:nvCxnSpPr>
        <p:spPr>
          <a:xfrm flipH="1">
            <a:off x="4167304" y="5743493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4548075" y="5615662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3109724" y="543714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77" name="TextBox 76"/>
          <p:cNvSpPr txBox="1"/>
          <p:nvPr/>
        </p:nvSpPr>
        <p:spPr>
          <a:xfrm>
            <a:off x="1907704" y="6309320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78" name="TextBox 77"/>
          <p:cNvSpPr txBox="1"/>
          <p:nvPr/>
        </p:nvSpPr>
        <p:spPr>
          <a:xfrm>
            <a:off x="3418522" y="630932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79" name="Straight Connector 78"/>
          <p:cNvCxnSpPr/>
          <p:nvPr/>
        </p:nvCxnSpPr>
        <p:spPr>
          <a:xfrm>
            <a:off x="1469343" y="6335588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3463488" y="6335588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 rot="16200000">
            <a:off x="1484113" y="229670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2" name="TextBox 81"/>
          <p:cNvSpPr txBox="1"/>
          <p:nvPr/>
        </p:nvSpPr>
        <p:spPr>
          <a:xfrm rot="16200000">
            <a:off x="2066341" y="226225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3" name="TextBox 82"/>
          <p:cNvSpPr txBox="1"/>
          <p:nvPr/>
        </p:nvSpPr>
        <p:spPr>
          <a:xfrm rot="16200000">
            <a:off x="2612207" y="224571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4" name="TextBox 83"/>
          <p:cNvSpPr txBox="1"/>
          <p:nvPr/>
        </p:nvSpPr>
        <p:spPr>
          <a:xfrm rot="16200000">
            <a:off x="3355055" y="2302737"/>
            <a:ext cx="3731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85" name="TextBox 84"/>
          <p:cNvSpPr txBox="1"/>
          <p:nvPr/>
        </p:nvSpPr>
        <p:spPr>
          <a:xfrm rot="16200000">
            <a:off x="1661676" y="227761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6" name="TextBox 85"/>
          <p:cNvSpPr txBox="1"/>
          <p:nvPr/>
        </p:nvSpPr>
        <p:spPr>
          <a:xfrm rot="16200000">
            <a:off x="2741796" y="224874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7" name="TextBox 86"/>
          <p:cNvSpPr txBox="1"/>
          <p:nvPr/>
        </p:nvSpPr>
        <p:spPr>
          <a:xfrm rot="16200000">
            <a:off x="3533884" y="234868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88" name="TextBox 87"/>
          <p:cNvSpPr txBox="1"/>
          <p:nvPr/>
        </p:nvSpPr>
        <p:spPr>
          <a:xfrm rot="16200000">
            <a:off x="3696881" y="217473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89" name="TextBox 88"/>
          <p:cNvSpPr txBox="1"/>
          <p:nvPr/>
        </p:nvSpPr>
        <p:spPr>
          <a:xfrm rot="16200000">
            <a:off x="1862339" y="229205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90" name="TextBox 89"/>
          <p:cNvSpPr txBox="1"/>
          <p:nvPr/>
        </p:nvSpPr>
        <p:spPr>
          <a:xfrm rot="16200000">
            <a:off x="2222379" y="22502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91" name="TextBox 90"/>
          <p:cNvSpPr txBox="1"/>
          <p:nvPr/>
        </p:nvSpPr>
        <p:spPr>
          <a:xfrm rot="16200000">
            <a:off x="3014467" y="220130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92" name="Straight Arrow Connector 91"/>
          <p:cNvCxnSpPr/>
          <p:nvPr/>
        </p:nvCxnSpPr>
        <p:spPr>
          <a:xfrm flipH="1">
            <a:off x="4191229" y="2397378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4572000" y="2269547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94" name="TextBox 93"/>
          <p:cNvSpPr txBox="1"/>
          <p:nvPr/>
        </p:nvSpPr>
        <p:spPr>
          <a:xfrm rot="16200000">
            <a:off x="3109724" y="229833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95" name="TextBox 94"/>
          <p:cNvSpPr txBox="1"/>
          <p:nvPr/>
        </p:nvSpPr>
        <p:spPr>
          <a:xfrm rot="16200000">
            <a:off x="2395758" y="224345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53D7C8D-788C-45FC-8A21-3DA0E3CC694A}"/>
              </a:ext>
            </a:extLst>
          </p:cNvPr>
          <p:cNvSpPr txBox="1"/>
          <p:nvPr/>
        </p:nvSpPr>
        <p:spPr>
          <a:xfrm>
            <a:off x="90741" y="3484439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B50D7D1-D794-4991-95D3-F9C01459B99A}"/>
              </a:ext>
            </a:extLst>
          </p:cNvPr>
          <p:cNvSpPr txBox="1"/>
          <p:nvPr/>
        </p:nvSpPr>
        <p:spPr>
          <a:xfrm>
            <a:off x="6653894" y="4400859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18B3D43-34B4-403C-85AD-907BA5732DD3}"/>
              </a:ext>
            </a:extLst>
          </p:cNvPr>
          <p:cNvSpPr txBox="1"/>
          <p:nvPr/>
        </p:nvSpPr>
        <p:spPr>
          <a:xfrm>
            <a:off x="4668565" y="5933229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</p:spTree>
    <p:extLst>
      <p:ext uri="{BB962C8B-B14F-4D97-AF65-F5344CB8AC3E}">
        <p14:creationId xmlns:p14="http://schemas.microsoft.com/office/powerpoint/2010/main" val="657472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3418" y="2170592"/>
            <a:ext cx="3548062" cy="1874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51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48" b="33849"/>
          <a:stretch/>
        </p:blipFill>
        <p:spPr bwMode="auto">
          <a:xfrm>
            <a:off x="1546852" y="165306"/>
            <a:ext cx="6305550" cy="2047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79" b="29274"/>
          <a:stretch/>
        </p:blipFill>
        <p:spPr bwMode="auto">
          <a:xfrm>
            <a:off x="3059832" y="5847241"/>
            <a:ext cx="3746500" cy="6187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9529" y="4045429"/>
            <a:ext cx="3113087" cy="1801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3851921" y="2492896"/>
            <a:ext cx="648072" cy="57606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/>
          <p:cNvSpPr/>
          <p:nvPr/>
        </p:nvSpPr>
        <p:spPr>
          <a:xfrm>
            <a:off x="4111713" y="4946334"/>
            <a:ext cx="648072" cy="42688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>
            <a:off x="4097867" y="6062133"/>
            <a:ext cx="618150" cy="3048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5436096" y="6079066"/>
            <a:ext cx="674368" cy="28786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5220072" y="3150326"/>
            <a:ext cx="674368" cy="42688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/>
          <p:cNvSpPr/>
          <p:nvPr/>
        </p:nvSpPr>
        <p:spPr>
          <a:xfrm>
            <a:off x="5220072" y="2531946"/>
            <a:ext cx="648072" cy="57606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" name="Straight Connector 4"/>
          <p:cNvCxnSpPr/>
          <p:nvPr/>
        </p:nvCxnSpPr>
        <p:spPr>
          <a:xfrm flipH="1" flipV="1">
            <a:off x="3707904" y="1111444"/>
            <a:ext cx="216024" cy="14205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stCxn id="16" idx="0"/>
          </p:cNvCxnSpPr>
          <p:nvPr/>
        </p:nvCxnSpPr>
        <p:spPr>
          <a:xfrm flipV="1">
            <a:off x="5544108" y="1189081"/>
            <a:ext cx="797372" cy="13428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5652120" y="1628800"/>
            <a:ext cx="576064" cy="152152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>
            <a:stCxn id="14" idx="0"/>
          </p:cNvCxnSpPr>
          <p:nvPr/>
        </p:nvCxnSpPr>
        <p:spPr>
          <a:xfrm flipV="1">
            <a:off x="5773280" y="1988842"/>
            <a:ext cx="670928" cy="40902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 flipV="1">
            <a:off x="3229529" y="1988840"/>
            <a:ext cx="1149304" cy="40324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>
            <a:stCxn id="9" idx="0"/>
          </p:cNvCxnSpPr>
          <p:nvPr/>
        </p:nvCxnSpPr>
        <p:spPr>
          <a:xfrm flipH="1" flipV="1">
            <a:off x="3491880" y="1781200"/>
            <a:ext cx="943869" cy="31651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3304034" y="237731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836343" y="233426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4370597" y="233426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5132487" y="226225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446420" y="238033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965932" y="231887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541996" y="227667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5292274" y="224686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5576557" y="22502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647440" y="234532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4166595" y="2322238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4742659" y="22502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35" name="Straight Arrow Connector 34"/>
          <p:cNvCxnSpPr/>
          <p:nvPr/>
        </p:nvCxnSpPr>
        <p:spPr>
          <a:xfrm flipH="1">
            <a:off x="5940326" y="2528972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6321097" y="2401141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4837916" y="234079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38" name="TextBox 37"/>
          <p:cNvSpPr txBox="1"/>
          <p:nvPr/>
        </p:nvSpPr>
        <p:spPr>
          <a:xfrm>
            <a:off x="3711545" y="3758843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5222363" y="375884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3273184" y="3785111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267329" y="3785111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962960" y="4077072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5473778" y="407707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3449924" y="4293096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5518744" y="429309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925278" y="6438141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5436096" y="643814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3486917" y="6464409"/>
            <a:ext cx="184215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481062" y="6464409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 rot="16200000">
            <a:off x="3430774" y="444981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4052367" y="440676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4628431" y="435048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5450717" y="440676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3636090" y="445283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4253964" y="436491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4830028" y="434917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5667757" y="439137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5894787" y="4394738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3878563" y="443355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4454627" y="433846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5030691" y="43227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62" name="Straight Arrow Connector 61"/>
          <p:cNvCxnSpPr/>
          <p:nvPr/>
        </p:nvCxnSpPr>
        <p:spPr>
          <a:xfrm flipH="1">
            <a:off x="6315809" y="4673480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6696580" y="454564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5156145" y="435702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3385475" y="577223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4052367" y="578968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4628431" y="574491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5405418" y="570835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3590791" y="577526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4208665" y="575934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4830028" y="574361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5550108" y="56610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5792581" y="56963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3833264" y="575598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4454627" y="573289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5072501" y="571716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7" name="Straight Arrow Connector 76"/>
          <p:cNvCxnSpPr/>
          <p:nvPr/>
        </p:nvCxnSpPr>
        <p:spPr>
          <a:xfrm flipH="1">
            <a:off x="6270510" y="5975072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6651281" y="5847241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5125948" y="572517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4FBC26E-5866-4CB6-B8C1-04FA842A3707}"/>
              </a:ext>
            </a:extLst>
          </p:cNvPr>
          <p:cNvSpPr txBox="1"/>
          <p:nvPr/>
        </p:nvSpPr>
        <p:spPr>
          <a:xfrm>
            <a:off x="6315809" y="2950219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4A9804D4-26F2-4B72-BA1D-5F184B000152}"/>
              </a:ext>
            </a:extLst>
          </p:cNvPr>
          <p:cNvSpPr txBox="1"/>
          <p:nvPr/>
        </p:nvSpPr>
        <p:spPr>
          <a:xfrm>
            <a:off x="6358928" y="5067055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D4F5DE9-9989-41D3-9ED9-173A120CAA4A}"/>
              </a:ext>
            </a:extLst>
          </p:cNvPr>
          <p:cNvSpPr txBox="1"/>
          <p:nvPr/>
        </p:nvSpPr>
        <p:spPr>
          <a:xfrm>
            <a:off x="6874251" y="6153748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</p:spTree>
    <p:extLst>
      <p:ext uri="{BB962C8B-B14F-4D97-AF65-F5344CB8AC3E}">
        <p14:creationId xmlns:p14="http://schemas.microsoft.com/office/powerpoint/2010/main" val="23494595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0640" y="2170592"/>
            <a:ext cx="3481387" cy="147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48" b="33849"/>
          <a:stretch/>
        </p:blipFill>
        <p:spPr bwMode="auto">
          <a:xfrm>
            <a:off x="1548402" y="181318"/>
            <a:ext cx="6305550" cy="2047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6977" y="3717032"/>
            <a:ext cx="3668712" cy="1619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5517233"/>
            <a:ext cx="3549650" cy="936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4474616" y="2371550"/>
            <a:ext cx="60143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3" name="Straight Connector 12"/>
          <p:cNvCxnSpPr>
            <a:stCxn id="6" idx="0"/>
          </p:cNvCxnSpPr>
          <p:nvPr/>
        </p:nvCxnSpPr>
        <p:spPr>
          <a:xfrm flipH="1" flipV="1">
            <a:off x="4624976" y="1268760"/>
            <a:ext cx="150360" cy="11027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 flipV="1">
            <a:off x="4474617" y="1700808"/>
            <a:ext cx="453120" cy="27363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4627016" y="4437112"/>
            <a:ext cx="60143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4627016" y="5733256"/>
            <a:ext cx="60143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4" name="Straight Connector 23"/>
          <p:cNvCxnSpPr>
            <a:stCxn id="19" idx="0"/>
          </p:cNvCxnSpPr>
          <p:nvPr/>
        </p:nvCxnSpPr>
        <p:spPr>
          <a:xfrm flipH="1" flipV="1">
            <a:off x="4067944" y="1988840"/>
            <a:ext cx="859792" cy="37444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5148064" y="2382990"/>
            <a:ext cx="60143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5148064" y="2875606"/>
            <a:ext cx="601439" cy="38768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5228455" y="5732506"/>
            <a:ext cx="601439" cy="50405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5448784" y="1268760"/>
            <a:ext cx="1715504" cy="11142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5749504" y="1700808"/>
            <a:ext cx="1342776" cy="13681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5529174" y="1988840"/>
            <a:ext cx="1635114" cy="37444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6200000">
            <a:off x="2983636" y="548420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620319" y="55016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4561162" y="545688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5169163" y="54203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188952" y="548722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4006192" y="54203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4690905" y="548722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5334249" y="536796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5538308" y="546763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3416317" y="551367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4378038" y="5436097"/>
            <a:ext cx="3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4958683" y="5436098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40" name="Straight Arrow Connector 39"/>
          <p:cNvCxnSpPr/>
          <p:nvPr/>
        </p:nvCxnSpPr>
        <p:spPr>
          <a:xfrm flipH="1">
            <a:off x="5868671" y="5687040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6249442" y="555920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3722798" y="551231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121419" y="543714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2969768" y="388283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606451" y="390028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547294" y="385551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5155295" y="381894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175084" y="388585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992324" y="381894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4716210" y="38608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5524440" y="383440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3402449" y="391230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4334138" y="3839210"/>
            <a:ext cx="3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4886675" y="383472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56" name="Straight Arrow Connector 55"/>
          <p:cNvCxnSpPr/>
          <p:nvPr/>
        </p:nvCxnSpPr>
        <p:spPr>
          <a:xfrm flipH="1">
            <a:off x="5854803" y="3943293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235574" y="3815462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3708930" y="391094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4076025" y="3885853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5334249" y="381894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2907929" y="230811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3506501" y="232556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4412407" y="228079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5093456" y="224422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3113245" y="231113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3852114" y="224422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4614004" y="228613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5462601" y="225968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3340610" y="233758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4220320" y="2264493"/>
            <a:ext cx="3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4824836" y="226000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72" name="Straight Arrow Connector 71"/>
          <p:cNvCxnSpPr/>
          <p:nvPr/>
        </p:nvCxnSpPr>
        <p:spPr>
          <a:xfrm flipH="1">
            <a:off x="5792964" y="2368576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6173735" y="2240745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3647091" y="2336223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4004017" y="231113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5272410" y="224422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77" name="TextBox 76"/>
          <p:cNvSpPr txBox="1"/>
          <p:nvPr/>
        </p:nvSpPr>
        <p:spPr>
          <a:xfrm>
            <a:off x="3619369" y="3525374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78" name="TextBox 77"/>
          <p:cNvSpPr txBox="1"/>
          <p:nvPr/>
        </p:nvSpPr>
        <p:spPr>
          <a:xfrm>
            <a:off x="5249845" y="351533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79" name="Straight Connector 78"/>
          <p:cNvCxnSpPr/>
          <p:nvPr/>
        </p:nvCxnSpPr>
        <p:spPr>
          <a:xfrm>
            <a:off x="3017648" y="3551642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5220144" y="3501008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3676066" y="5157192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82" name="TextBox 81"/>
          <p:cNvSpPr txBox="1"/>
          <p:nvPr/>
        </p:nvSpPr>
        <p:spPr>
          <a:xfrm>
            <a:off x="5306542" y="515940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83" name="Straight Connector 82"/>
          <p:cNvCxnSpPr/>
          <p:nvPr/>
        </p:nvCxnSpPr>
        <p:spPr>
          <a:xfrm>
            <a:off x="3074345" y="5157192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5276841" y="5145074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3664582" y="6340263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86" name="TextBox 85"/>
          <p:cNvSpPr txBox="1"/>
          <p:nvPr/>
        </p:nvSpPr>
        <p:spPr>
          <a:xfrm>
            <a:off x="5300233" y="634026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87" name="Straight Connector 86"/>
          <p:cNvCxnSpPr/>
          <p:nvPr/>
        </p:nvCxnSpPr>
        <p:spPr>
          <a:xfrm>
            <a:off x="3062861" y="6366531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5270532" y="6366531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3F7922E2-9C45-4447-A025-B4478CBDB6FB}"/>
              </a:ext>
            </a:extLst>
          </p:cNvPr>
          <p:cNvSpPr txBox="1"/>
          <p:nvPr/>
        </p:nvSpPr>
        <p:spPr>
          <a:xfrm>
            <a:off x="6164524" y="2897464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EC0E0CF-C79B-4D83-9418-8FDE2F66290C}"/>
              </a:ext>
            </a:extLst>
          </p:cNvPr>
          <p:cNvSpPr txBox="1"/>
          <p:nvPr/>
        </p:nvSpPr>
        <p:spPr>
          <a:xfrm>
            <a:off x="6208206" y="4551099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E30007C-9EE6-4E90-B89C-B73A3A77F8A7}"/>
              </a:ext>
            </a:extLst>
          </p:cNvPr>
          <p:cNvSpPr txBox="1"/>
          <p:nvPr/>
        </p:nvSpPr>
        <p:spPr>
          <a:xfrm>
            <a:off x="6271390" y="5966421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</p:spTree>
    <p:extLst>
      <p:ext uri="{BB962C8B-B14F-4D97-AF65-F5344CB8AC3E}">
        <p14:creationId xmlns:p14="http://schemas.microsoft.com/office/powerpoint/2010/main" val="38232736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54365" y="237291"/>
            <a:ext cx="6305550" cy="1994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566487" y="2540904"/>
            <a:ext cx="3154362" cy="1581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391183" y="4221087"/>
            <a:ext cx="3214687" cy="720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2761039" y="2668969"/>
            <a:ext cx="731201" cy="6015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8" name="Straight Connector 7"/>
          <p:cNvCxnSpPr>
            <a:stCxn id="7" idx="0"/>
          </p:cNvCxnSpPr>
          <p:nvPr/>
        </p:nvCxnSpPr>
        <p:spPr>
          <a:xfrm flipV="1">
            <a:off x="3126640" y="1052736"/>
            <a:ext cx="2346064" cy="16162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2761039" y="3325368"/>
            <a:ext cx="731201" cy="46367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3234291" y="4437433"/>
            <a:ext cx="731201" cy="2880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3631400" y="2740988"/>
            <a:ext cx="634868" cy="6015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>
            <a:off x="3605404" y="3429000"/>
            <a:ext cx="660864" cy="3600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2462016" y="4430648"/>
            <a:ext cx="731201" cy="2880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5" name="Straight Connector 14"/>
          <p:cNvCxnSpPr/>
          <p:nvPr/>
        </p:nvCxnSpPr>
        <p:spPr>
          <a:xfrm flipH="1" flipV="1">
            <a:off x="2987824" y="1628800"/>
            <a:ext cx="643576" cy="1800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 flipV="1">
            <a:off x="2566488" y="2035336"/>
            <a:ext cx="1064912" cy="2395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>
            <a:stCxn id="12" idx="0"/>
          </p:cNvCxnSpPr>
          <p:nvPr/>
        </p:nvCxnSpPr>
        <p:spPr>
          <a:xfrm flipH="1" flipV="1">
            <a:off x="2987824" y="1210444"/>
            <a:ext cx="961010" cy="15305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3059832" y="1628800"/>
            <a:ext cx="2412872" cy="17026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2827616" y="2035336"/>
            <a:ext cx="3040528" cy="2395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835560" y="4809548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2507656" y="480954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233839" y="4835816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2477955" y="483581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143668" y="3959102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2815764" y="395910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27" name="Straight Connector 26"/>
          <p:cNvCxnSpPr/>
          <p:nvPr/>
        </p:nvCxnSpPr>
        <p:spPr>
          <a:xfrm>
            <a:off x="3541947" y="3985370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786063" y="3985370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 rot="16200000">
            <a:off x="2756223" y="230919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2952650" y="234080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158483" y="2340801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5720849" y="4307321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3298128" y="234080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2426381" y="416736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2622808" y="419897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2828641" y="419897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2968286" y="4198972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3244543" y="417830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3440970" y="4209911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3646803" y="4194446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3852047" y="420551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4048474" y="4191084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254307" y="41910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4442605" y="416331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4639032" y="414888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886675" y="4122438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3615314" y="232464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811741" y="23562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4017574" y="234079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4196383" y="23518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4356170" y="233742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4568445" y="2337429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4730637" y="230965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4902036" y="234868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5144509" y="230873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7" name="TextBox 56"/>
          <p:cNvSpPr txBox="1"/>
          <p:nvPr/>
        </p:nvSpPr>
        <p:spPr>
          <a:xfrm>
            <a:off x="6072253" y="417060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cxnSp>
        <p:nvCxnSpPr>
          <p:cNvPr id="59" name="Straight Arrow Connector 58"/>
          <p:cNvCxnSpPr/>
          <p:nvPr/>
        </p:nvCxnSpPr>
        <p:spPr>
          <a:xfrm flipH="1">
            <a:off x="5720849" y="2530566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6072253" y="2393854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8985DDB-1281-4F5C-8DFE-DEE60398AFC7}"/>
              </a:ext>
            </a:extLst>
          </p:cNvPr>
          <p:cNvSpPr txBox="1"/>
          <p:nvPr/>
        </p:nvSpPr>
        <p:spPr>
          <a:xfrm>
            <a:off x="5829312" y="3177729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20FE45A-3E0B-4BCD-A3C0-FEDA0D74225F}"/>
              </a:ext>
            </a:extLst>
          </p:cNvPr>
          <p:cNvSpPr txBox="1"/>
          <p:nvPr/>
        </p:nvSpPr>
        <p:spPr>
          <a:xfrm>
            <a:off x="5828082" y="4437433"/>
            <a:ext cx="879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Cortex</a:t>
            </a:r>
          </a:p>
        </p:txBody>
      </p:sp>
    </p:spTree>
    <p:extLst>
      <p:ext uri="{BB962C8B-B14F-4D97-AF65-F5344CB8AC3E}">
        <p14:creationId xmlns:p14="http://schemas.microsoft.com/office/powerpoint/2010/main" val="27412030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70738" y="237291"/>
            <a:ext cx="6305550" cy="1994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989336" y="2467794"/>
            <a:ext cx="3278187" cy="146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052808" y="3933056"/>
            <a:ext cx="2944812" cy="7200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Rectangle 9"/>
          <p:cNvSpPr/>
          <p:nvPr/>
        </p:nvSpPr>
        <p:spPr>
          <a:xfrm>
            <a:off x="4210997" y="2569115"/>
            <a:ext cx="443057" cy="6015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" name="Straight Connector 10"/>
          <p:cNvCxnSpPr/>
          <p:nvPr/>
        </p:nvCxnSpPr>
        <p:spPr>
          <a:xfrm flipH="1" flipV="1">
            <a:off x="3837757" y="908720"/>
            <a:ext cx="1473425" cy="16603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5189565" y="2581152"/>
            <a:ext cx="221529" cy="6015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5" name="Straight Connector 14"/>
          <p:cNvCxnSpPr>
            <a:stCxn id="10" idx="0"/>
          </p:cNvCxnSpPr>
          <p:nvPr/>
        </p:nvCxnSpPr>
        <p:spPr>
          <a:xfrm flipH="1" flipV="1">
            <a:off x="3563888" y="1340768"/>
            <a:ext cx="868638" cy="12283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4180456" y="3277480"/>
            <a:ext cx="443057" cy="36754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5200417" y="3277480"/>
            <a:ext cx="210677" cy="36754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3957161" y="4149080"/>
            <a:ext cx="443057" cy="28803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5089652" y="4187930"/>
            <a:ext cx="221529" cy="2880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4" name="Straight Connector 23"/>
          <p:cNvCxnSpPr/>
          <p:nvPr/>
        </p:nvCxnSpPr>
        <p:spPr>
          <a:xfrm flipH="1" flipV="1">
            <a:off x="3529218" y="1808055"/>
            <a:ext cx="903307" cy="14694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3810438" y="1916832"/>
            <a:ext cx="2417746" cy="227301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 flipV="1">
            <a:off x="3723166" y="1808055"/>
            <a:ext cx="1588016" cy="14694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H="1" flipV="1">
            <a:off x="3203848" y="1997224"/>
            <a:ext cx="1080120" cy="219262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3320748" y="2524383"/>
            <a:ext cx="644258" cy="60157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3310444" y="3170692"/>
            <a:ext cx="644258" cy="4053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Rectangle 40"/>
          <p:cNvSpPr/>
          <p:nvPr/>
        </p:nvSpPr>
        <p:spPr>
          <a:xfrm>
            <a:off x="3122225" y="4187930"/>
            <a:ext cx="813987" cy="2880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2" name="Straight Connector 41"/>
          <p:cNvCxnSpPr>
            <a:stCxn id="21" idx="0"/>
          </p:cNvCxnSpPr>
          <p:nvPr/>
        </p:nvCxnSpPr>
        <p:spPr>
          <a:xfrm flipH="1" flipV="1">
            <a:off x="3851920" y="1997224"/>
            <a:ext cx="1348497" cy="21907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3851920" y="1700808"/>
            <a:ext cx="2376264" cy="153990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3837757" y="1340768"/>
            <a:ext cx="2429766" cy="17518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6092804" y="4528238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6444208" y="4391526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6524852" y="2607471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876256" y="247075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3888109" y="4869160"/>
            <a:ext cx="2109511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132225" y="4869160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3116263" y="444137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3317860" y="445675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3590531" y="445339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3643977" y="444886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3898813" y="444232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140146" y="44369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4352421" y="441047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556423" y="442249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4758020" y="44369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5030691" y="443355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5334084" y="44369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5576557" y="443355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5084137" y="448700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cxnSp>
        <p:nvCxnSpPr>
          <p:cNvPr id="55" name="Straight Connector 54"/>
          <p:cNvCxnSpPr/>
          <p:nvPr/>
        </p:nvCxnSpPr>
        <p:spPr>
          <a:xfrm>
            <a:off x="4134809" y="2445053"/>
            <a:ext cx="1836000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3332871" y="2445053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6200000">
            <a:off x="3324833" y="380994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3548982" y="37888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3775320" y="378884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3783020" y="356493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4124375" y="37744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4310938" y="377441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4496437" y="379792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4700439" y="378590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4879942" y="37888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5144200" y="378548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5499466" y="375903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5751094" y="377018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5227218" y="368422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70" name="TextBox 69"/>
          <p:cNvSpPr txBox="1"/>
          <p:nvPr/>
        </p:nvSpPr>
        <p:spPr>
          <a:xfrm>
            <a:off x="4513277" y="4932658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71" name="TextBox 70"/>
          <p:cNvSpPr txBox="1"/>
          <p:nvPr/>
        </p:nvSpPr>
        <p:spPr>
          <a:xfrm>
            <a:off x="3185373" y="493265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sp>
        <p:nvSpPr>
          <p:cNvPr id="72" name="TextBox 71"/>
          <p:cNvSpPr txBox="1"/>
          <p:nvPr/>
        </p:nvSpPr>
        <p:spPr>
          <a:xfrm>
            <a:off x="4707752" y="2210402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73" name="TextBox 72"/>
          <p:cNvSpPr txBox="1"/>
          <p:nvPr/>
        </p:nvSpPr>
        <p:spPr>
          <a:xfrm>
            <a:off x="3347864" y="220486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BD982EC-8E9E-4E82-A9AA-C22FC9078A34}"/>
              </a:ext>
            </a:extLst>
          </p:cNvPr>
          <p:cNvSpPr txBox="1"/>
          <p:nvPr/>
        </p:nvSpPr>
        <p:spPr>
          <a:xfrm>
            <a:off x="6388063" y="3165626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63ED3AB-5572-4750-803F-A07F41B27C7B}"/>
              </a:ext>
            </a:extLst>
          </p:cNvPr>
          <p:cNvSpPr txBox="1"/>
          <p:nvPr/>
        </p:nvSpPr>
        <p:spPr>
          <a:xfrm>
            <a:off x="1428355" y="4169374"/>
            <a:ext cx="16419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Hippocampus</a:t>
            </a:r>
          </a:p>
        </p:txBody>
      </p:sp>
    </p:spTree>
    <p:extLst>
      <p:ext uri="{BB962C8B-B14F-4D97-AF65-F5344CB8AC3E}">
        <p14:creationId xmlns:p14="http://schemas.microsoft.com/office/powerpoint/2010/main" val="21844102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54365" y="237291"/>
            <a:ext cx="6305550" cy="1994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551310" y="2639208"/>
            <a:ext cx="3168650" cy="15121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635896" y="4693238"/>
            <a:ext cx="3175000" cy="10715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4875924" y="2790292"/>
            <a:ext cx="401115" cy="49469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9" name="Straight Connector 8"/>
          <p:cNvCxnSpPr/>
          <p:nvPr/>
        </p:nvCxnSpPr>
        <p:spPr>
          <a:xfrm flipH="1" flipV="1">
            <a:off x="4628431" y="1340768"/>
            <a:ext cx="375618" cy="14495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5278305" y="2790292"/>
            <a:ext cx="200843" cy="49469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4" name="Straight Connector 13"/>
          <p:cNvCxnSpPr/>
          <p:nvPr/>
        </p:nvCxnSpPr>
        <p:spPr>
          <a:xfrm flipH="1" flipV="1">
            <a:off x="4067944" y="1340768"/>
            <a:ext cx="1310783" cy="151216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891164" y="3501008"/>
            <a:ext cx="401115" cy="3752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5293545" y="3501008"/>
            <a:ext cx="200843" cy="3752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9" name="Straight Connector 18"/>
          <p:cNvCxnSpPr>
            <a:stCxn id="18" idx="0"/>
          </p:cNvCxnSpPr>
          <p:nvPr/>
        </p:nvCxnSpPr>
        <p:spPr>
          <a:xfrm flipH="1" flipV="1">
            <a:off x="4067944" y="1772816"/>
            <a:ext cx="1326023" cy="17281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 flipV="1">
            <a:off x="4355976" y="1772816"/>
            <a:ext cx="779659" cy="17281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4939100" y="4877355"/>
            <a:ext cx="439626" cy="3752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5379269" y="4877355"/>
            <a:ext cx="200843" cy="3752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7" name="Straight Connector 26"/>
          <p:cNvCxnSpPr/>
          <p:nvPr/>
        </p:nvCxnSpPr>
        <p:spPr>
          <a:xfrm flipH="1" flipV="1">
            <a:off x="4628431" y="2065530"/>
            <a:ext cx="594965" cy="28118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4355976" y="2065531"/>
            <a:ext cx="3024336" cy="2811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/>
          <p:cNvSpPr/>
          <p:nvPr/>
        </p:nvSpPr>
        <p:spPr>
          <a:xfrm>
            <a:off x="3881420" y="2790293"/>
            <a:ext cx="796685" cy="49469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/>
          <p:cNvSpPr/>
          <p:nvPr/>
        </p:nvSpPr>
        <p:spPr>
          <a:xfrm>
            <a:off x="3865419" y="3474720"/>
            <a:ext cx="763011" cy="37490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3881420" y="4888600"/>
            <a:ext cx="813987" cy="2880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2" name="Straight Connector 41"/>
          <p:cNvCxnSpPr/>
          <p:nvPr/>
        </p:nvCxnSpPr>
        <p:spPr>
          <a:xfrm flipV="1">
            <a:off x="4628430" y="1772816"/>
            <a:ext cx="2463850" cy="17019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4628430" y="1340768"/>
            <a:ext cx="2463850" cy="15121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>
            <a:off x="6802759" y="5276774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154163" y="5140062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4766745" y="5617696"/>
            <a:ext cx="1908000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842180" y="5617696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 rot="16200000">
            <a:off x="3866541" y="518990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4109948" y="520529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4352421" y="520193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4405868" y="513507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4608768" y="519086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4860226" y="519919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5062376" y="5225645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5306701" y="521362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5467975" y="519919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5678763" y="518209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6054164" y="518545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6286512" y="518209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5223232" y="5681194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50" name="TextBox 49"/>
          <p:cNvSpPr txBox="1"/>
          <p:nvPr/>
        </p:nvSpPr>
        <p:spPr>
          <a:xfrm>
            <a:off x="3895328" y="568119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5882765" y="519086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4680224" y="4112278"/>
            <a:ext cx="1908000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3907446" y="4112278"/>
            <a:ext cx="6480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136711" y="4175776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Transgenic</a:t>
            </a:r>
            <a:endParaRPr lang="en-GB" sz="1000" dirty="0"/>
          </a:p>
        </p:txBody>
      </p:sp>
      <p:sp>
        <p:nvSpPr>
          <p:cNvPr id="55" name="TextBox 54"/>
          <p:cNvSpPr txBox="1"/>
          <p:nvPr/>
        </p:nvSpPr>
        <p:spPr>
          <a:xfrm>
            <a:off x="3960594" y="417577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R6</a:t>
            </a:r>
            <a:r>
              <a:rPr lang="en-US" sz="1000" dirty="0"/>
              <a:t>/2 WT</a:t>
            </a:r>
            <a:endParaRPr lang="en-GB" sz="1000" dirty="0"/>
          </a:p>
        </p:txBody>
      </p:sp>
      <p:cxnSp>
        <p:nvCxnSpPr>
          <p:cNvPr id="56" name="Straight Arrow Connector 55"/>
          <p:cNvCxnSpPr/>
          <p:nvPr/>
        </p:nvCxnSpPr>
        <p:spPr>
          <a:xfrm flipH="1">
            <a:off x="6667503" y="2580921"/>
            <a:ext cx="33306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7018907" y="2444209"/>
            <a:ext cx="107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SIRT2</a:t>
            </a:r>
            <a:r>
              <a:rPr lang="en-US" sz="1100" dirty="0"/>
              <a:t> genotype</a:t>
            </a:r>
            <a:endParaRPr lang="en-GB" sz="11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3836343" y="24940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4068138" y="250943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4352421" y="2506077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4658629" y="24782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4830028" y="249270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5030691" y="2529792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5171445" y="251777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5332719" y="250334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5543507" y="248624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5918908" y="248960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ET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6151256" y="2486240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KO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5747509" y="249501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WT</a:t>
            </a:r>
            <a:endParaRPr lang="en-GB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4436065" y="2916863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mpty</a:t>
            </a:r>
            <a:endParaRPr lang="en-GB" sz="1000" i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DA6E222-8307-4D1A-94A8-5AC0B3480477}"/>
              </a:ext>
            </a:extLst>
          </p:cNvPr>
          <p:cNvSpPr txBox="1"/>
          <p:nvPr/>
        </p:nvSpPr>
        <p:spPr>
          <a:xfrm>
            <a:off x="6884104" y="3212883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05F8E8C-FFEA-4BC4-99BC-51AEE53E20C0}"/>
              </a:ext>
            </a:extLst>
          </p:cNvPr>
          <p:cNvSpPr txBox="1"/>
          <p:nvPr/>
        </p:nvSpPr>
        <p:spPr>
          <a:xfrm>
            <a:off x="6819801" y="5528704"/>
            <a:ext cx="13223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rain stem</a:t>
            </a:r>
          </a:p>
        </p:txBody>
      </p:sp>
    </p:spTree>
    <p:extLst>
      <p:ext uri="{BB962C8B-B14F-4D97-AF65-F5344CB8AC3E}">
        <p14:creationId xmlns:p14="http://schemas.microsoft.com/office/powerpoint/2010/main" val="1618209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7</TotalTime>
  <Words>491</Words>
  <Application>Microsoft Office PowerPoint</Application>
  <PresentationFormat>On-screen Show (4:3)</PresentationFormat>
  <Paragraphs>411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nia Bobrowska</cp:lastModifiedBy>
  <cp:revision>43</cp:revision>
  <cp:lastPrinted>2019-02-24T15:02:53Z</cp:lastPrinted>
  <dcterms:created xsi:type="dcterms:W3CDTF">2018-10-14T17:24:21Z</dcterms:created>
  <dcterms:modified xsi:type="dcterms:W3CDTF">2020-09-26T12:09:05Z</dcterms:modified>
</cp:coreProperties>
</file>